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59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eriments\OO2105\DATA\gut%20permeability\OO2105-gut%20permeability-6.16.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5"/>
                <c:pt idx="0">
                  <c:v>4.0000000000000001E-3</c:v>
                </c:pt>
                <c:pt idx="1">
                  <c:v>0.06</c:v>
                </c:pt>
                <c:pt idx="2">
                  <c:v>0.1</c:v>
                </c:pt>
                <c:pt idx="3">
                  <c:v>0.1</c:v>
                </c:pt>
                <c:pt idx="4">
                  <c:v>0.03</c:v>
                </c:pt>
              </c:numLit>
            </c:plus>
            <c:minus>
              <c:numLit>
                <c:formatCode>General</c:formatCode>
                <c:ptCount val="5"/>
                <c:pt idx="0">
                  <c:v>4.0000000000000001E-3</c:v>
                </c:pt>
                <c:pt idx="1">
                  <c:v>0.06</c:v>
                </c:pt>
                <c:pt idx="2">
                  <c:v>0.1</c:v>
                </c:pt>
                <c:pt idx="3">
                  <c:v>0.1</c:v>
                </c:pt>
                <c:pt idx="4">
                  <c:v>0.03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N$14:$N$18</c:f>
              <c:strCache>
                <c:ptCount val="5"/>
                <c:pt idx="0">
                  <c:v>NC</c:v>
                </c:pt>
                <c:pt idx="1">
                  <c:v>C</c:v>
                </c:pt>
                <c:pt idx="2">
                  <c:v>C+PRO</c:v>
                </c:pt>
                <c:pt idx="3">
                  <c:v>C+PRO+XYL</c:v>
                </c:pt>
                <c:pt idx="4">
                  <c:v>C+XOS</c:v>
                </c:pt>
              </c:strCache>
            </c:strRef>
          </c:cat>
          <c:val>
            <c:numRef>
              <c:f>Summary!$O$14:$O$18</c:f>
              <c:numCache>
                <c:formatCode>General</c:formatCode>
                <c:ptCount val="5"/>
                <c:pt idx="0">
                  <c:v>-1.4999999999999999E-2</c:v>
                </c:pt>
                <c:pt idx="1">
                  <c:v>0.1105317</c:v>
                </c:pt>
                <c:pt idx="2">
                  <c:v>0.40400000000000003</c:v>
                </c:pt>
                <c:pt idx="3">
                  <c:v>0.2662033682142857</c:v>
                </c:pt>
                <c:pt idx="4">
                  <c:v>0.484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01-498B-B83F-C575043D31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8891216"/>
        <c:axId val="818892200"/>
      </c:barChart>
      <c:catAx>
        <c:axId val="818891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8892200"/>
        <c:crosses val="autoZero"/>
        <c:auto val="1"/>
        <c:lblAlgn val="ctr"/>
        <c:lblOffset val="100"/>
        <c:noMultiLvlLbl val="0"/>
      </c:catAx>
      <c:valAx>
        <c:axId val="8188922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8891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8B6717-B3D6-501A-A6CE-66234D7523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2E6E1EE-7D9B-7F31-912D-33671B838D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C8F15E-32AA-FF41-B073-CFF141B74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32B335-75A9-2745-3426-EC95E84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151FAB-3F3E-A4F5-EB09-98966E3AB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388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A985DA-B2BB-5712-90F1-51A07B4DFA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3F4788-9595-5FC0-0EEC-368B1E0EC5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A4D58D-1F56-F113-BA40-878303CED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A3434C-BF35-B369-F8DC-8B0AFBDFE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FD0307-C3F2-6FB0-C3DE-4C14AC477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20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C7956C-8C7C-F5F6-114B-A72BD3A60A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2A13E20-1EF9-ED27-9287-DA27262C03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42F746-AAEB-7FB9-FEB9-C9C91A2D7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B8ECCD-4E55-15A0-086E-663C15E9D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889E44-7C40-90D8-4184-C5D5CD8FF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64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0DFB6A-D314-972A-0104-A3FB0EE3F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F33D70-AB5D-A00E-9E29-BB7E39C41E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2DF5BF-E551-35E4-4452-7D5EBA38E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DA712B-98B8-5633-45D9-206768471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283041-2D40-1CA7-3C09-0B18007B0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01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FF26E5-9EF9-5C07-755F-D51BC2CF1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22033E-D5C0-E23B-B65B-6268996B9F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2CF7E3-0F3B-26D9-3085-9F3879B98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5F4285-A689-EA73-36FC-52503E27B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32E88B-DEA0-59DB-E688-0881BC628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261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FE8AE6-D0C5-A6CF-3506-46533B8DD6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85F2A5A-6A5F-8262-4533-7A6C79368D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0D6465A-71BF-BC57-E5B4-698936B8A4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FA34FE-A514-9A37-F0E0-D1BD50CF9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07294E-044B-E3B7-1420-A4F48FB46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0746D1F-6585-7AA5-0971-8DB7DF911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590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570772-4D9F-0AC1-5A40-615E648E6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72969D-3678-920E-BB8E-DDF6986C05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D86D68-282E-1B90-4CBE-B362398D36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D48EE1D-8030-827E-93F3-64CB081291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C34CA47-65D1-6906-7F1F-3EFBD3EB4E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212EBAD-8150-B224-90F5-C5A4ABF36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61B0CA1-6585-1A17-713D-914CBE5B8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2DC116E-7D89-2FBA-100E-6092DE438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861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59900D-0649-9A7A-6BE0-F8E9C3ED7A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5A7A23-C8A9-67A4-1E9D-5465AB7FE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3BCD5FF-41B7-A716-31A6-DB5278202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FA7A310-A34A-9E5F-32E5-5542FB36F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898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E52AA2D-6720-EA6D-8294-B08A9DEEF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20F3AC-25C0-AEE4-2E3A-13D9E25E6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4590148-F389-5C65-D295-E7520CBC3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888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EE7C19-8408-8EE3-EC6D-EE3E51FFB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D775C5-31CF-CC29-5E89-60E8DC5CB8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9BDA8E-0851-6AC3-A0CD-3D2D7344DC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5E3151-E3A5-9457-5966-826A8AAD9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DE4C88-EEBF-3748-9118-8F3D8E498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13EBF7-4F7B-1998-FECD-5A02C33F1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522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120694-2E64-0DD1-F9A2-5279F4BD7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BA6041-88F1-8517-8467-F9D3DC9527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4228C9-09FD-5AE0-77D7-B2B286B96E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588D700-7C3A-5F00-A91D-CC8FFA017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50FDA4-32FF-CDD5-62CC-F7261F0E8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8350B0-94D9-A7ED-5697-9F6E17FF0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727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1A52666-661C-D076-0D5A-507943C46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C7C352-B585-6D26-0560-5BB94939C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9414FB-5E7F-A291-428A-29121BBFF5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73603-A425-4F99-9C9B-5C1C15F9E28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B40939-3940-BE46-7711-A4DBD587FA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FB8FD8-4FEA-35F2-77DE-8D095E1AF8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8A78D-900F-416D-84AF-8110F8259E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651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31465F7D-8801-18F5-06A7-54AD908F0E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4149963"/>
              </p:ext>
            </p:extLst>
          </p:nvPr>
        </p:nvGraphicFramePr>
        <p:xfrm>
          <a:off x="1382233" y="558209"/>
          <a:ext cx="9197162" cy="57415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923038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D04DEE-E98E-3103-D5A8-E3BB068404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843366-DDC7-C6E7-16ED-8685D8B635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luorescein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isothiocyanate dextran concentration (FITC-d, µg/mL) in serum of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Eimeri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-challenged broiler chickens in response to dietary supplementations (5 DPI)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 Uni"/>
                <a:cs typeface="Arial" panose="020B0604020202020204" pitchFamily="34" charset="0"/>
              </a:rPr>
              <a:t> N = 7. NC, unchallenged-no supplementation treatment; C, challenged-no supplementation treatment; C+PRO, challenged and supplemented with protease treatment; C+PRO+XYL, challenged and supplemented with protease and xylanase treatment; C+XOS, challenged and supplemented with xylo-oligosaccharides treatment. The error bars represent the SEM values.</a:t>
            </a:r>
            <a:endParaRPr lang="en-US" sz="18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4821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2</TotalTime>
  <Words>87</Words>
  <Application>Microsoft Office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Lin</dc:creator>
  <cp:lastModifiedBy>Yang Lin</cp:lastModifiedBy>
  <cp:revision>7</cp:revision>
  <dcterms:created xsi:type="dcterms:W3CDTF">2022-09-14T20:04:56Z</dcterms:created>
  <dcterms:modified xsi:type="dcterms:W3CDTF">2023-05-09T19:15:06Z</dcterms:modified>
</cp:coreProperties>
</file>